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1A28F-9907-42E2-8867-C225E5096E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7A527-91B2-46F3-B2D1-47ED63F374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34C43-74A3-44CC-9A07-7F8EFA2C1C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35B37-5138-4C6F-9F5C-035CAAFE51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BCD7F-93DE-4B8D-9499-BE9E697EA0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F59B2-6106-49A6-96A9-2C127EAFC9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9AAEC-6CF1-4DA4-9E28-74FD29C3E7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68EB8-372F-4D4B-AE1B-6FCA76D15C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79F58-BAA7-432F-8D04-DB974484BB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03D5E-32ED-4FEB-873D-81C235356A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6E6B4-8084-498D-AD41-756369178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96D73-102B-4F62-9D8D-BB26AC331A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573167-C49D-44FB-94AF-058AABDC406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7" descr=""/>
          <p:cNvPicPr/>
          <p:nvPr/>
        </p:nvPicPr>
        <p:blipFill>
          <a:blip r:embed="rId1"/>
          <a:stretch/>
        </p:blipFill>
        <p:spPr>
          <a:xfrm>
            <a:off x="871560" y="341280"/>
            <a:ext cx="5443560" cy="267660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36"/>
          <p:cNvGrpSpPr/>
          <p:nvPr/>
        </p:nvGrpSpPr>
        <p:grpSpPr>
          <a:xfrm>
            <a:off x="657360" y="960480"/>
            <a:ext cx="6181560" cy="2316600"/>
            <a:chOff x="657360" y="960480"/>
            <a:chExt cx="6181560" cy="2316600"/>
          </a:xfrm>
        </p:grpSpPr>
        <p:pic>
          <p:nvPicPr>
            <p:cNvPr id="43" name="Picture 3" descr=""/>
            <p:cNvPicPr/>
            <p:nvPr/>
          </p:nvPicPr>
          <p:blipFill>
            <a:blip r:embed="rId2"/>
            <a:srcRect l="75720" t="40236" r="0" b="21670"/>
            <a:stretch/>
          </p:blipFill>
          <p:spPr>
            <a:xfrm>
              <a:off x="5381640" y="1133280"/>
              <a:ext cx="1457280" cy="111420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44" name="Straight Arrow Connector 27"/>
            <p:cNvCxnSpPr/>
            <p:nvPr/>
          </p:nvCxnSpPr>
          <p:spPr>
            <a:xfrm>
              <a:off x="1914480" y="1238040"/>
              <a:ext cx="143280" cy="54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5" name="TextBox 29"/>
            <p:cNvSpPr/>
            <p:nvPr/>
          </p:nvSpPr>
          <p:spPr>
            <a:xfrm>
              <a:off x="1685520" y="990360"/>
              <a:ext cx="4532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r>
                <a:rPr b="0" lang="en-I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r>
                <a:rPr b="0" lang="en-I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31"/>
            <p:cNvSpPr/>
            <p:nvPr/>
          </p:nvSpPr>
          <p:spPr>
            <a:xfrm rot="16200000">
              <a:off x="217440" y="1400040"/>
              <a:ext cx="112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Log (OD600n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33"/>
            <p:cNvSpPr/>
            <p:nvPr/>
          </p:nvSpPr>
          <p:spPr>
            <a:xfrm>
              <a:off x="2315520" y="3009960"/>
              <a:ext cx="20887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Time post addition of H</a:t>
              </a:r>
              <a:r>
                <a:rPr b="1" lang="en-I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r>
                <a:rPr b="1" lang="en-I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 (hr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Group 35"/>
          <p:cNvGrpSpPr/>
          <p:nvPr/>
        </p:nvGrpSpPr>
        <p:grpSpPr>
          <a:xfrm>
            <a:off x="666720" y="3722760"/>
            <a:ext cx="6488640" cy="3135240"/>
            <a:chOff x="666720" y="3722760"/>
            <a:chExt cx="6488640" cy="3135240"/>
          </a:xfrm>
        </p:grpSpPr>
        <p:grpSp>
          <p:nvGrpSpPr>
            <p:cNvPr id="49" name="Group 13"/>
            <p:cNvGrpSpPr/>
            <p:nvPr/>
          </p:nvGrpSpPr>
          <p:grpSpPr>
            <a:xfrm>
              <a:off x="826560" y="3722760"/>
              <a:ext cx="6328800" cy="2919600"/>
              <a:chOff x="826560" y="3722760"/>
              <a:chExt cx="6328800" cy="2919600"/>
            </a:xfrm>
          </p:grpSpPr>
          <p:pic>
            <p:nvPicPr>
              <p:cNvPr id="50" name="Chart 4" descr=""/>
              <p:cNvPicPr/>
              <p:nvPr/>
            </p:nvPicPr>
            <p:blipFill>
              <a:blip r:embed="rId3"/>
              <a:stretch/>
            </p:blipFill>
            <p:spPr>
              <a:xfrm>
                <a:off x="826560" y="3722760"/>
                <a:ext cx="5995080" cy="291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TextBox 9"/>
              <p:cNvSpPr/>
              <p:nvPr/>
            </p:nvSpPr>
            <p:spPr>
              <a:xfrm>
                <a:off x="5729760" y="4945680"/>
                <a:ext cx="62280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IE" sz="1000" spc="-1" strike="noStrike">
                    <a:solidFill>
                      <a:srgbClr val="000000"/>
                    </a:solidFill>
                    <a:latin typeface="Arial"/>
                  </a:rPr>
                  <a:t>mPAO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10"/>
              <p:cNvSpPr/>
              <p:nvPr/>
            </p:nvSpPr>
            <p:spPr>
              <a:xfrm>
                <a:off x="5734440" y="5160960"/>
                <a:ext cx="138924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IE" sz="1000" spc="-1" strike="noStrike">
                    <a:solidFill>
                      <a:srgbClr val="000000"/>
                    </a:solidFill>
                    <a:latin typeface="Arial"/>
                  </a:rPr>
                  <a:t>mPAO1 + menadio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11"/>
              <p:cNvSpPr/>
              <p:nvPr/>
            </p:nvSpPr>
            <p:spPr>
              <a:xfrm>
                <a:off x="5735520" y="5632560"/>
                <a:ext cx="141984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IE" sz="1000" spc="-1" strike="noStrike">
                    <a:solidFill>
                      <a:srgbClr val="000000"/>
                    </a:solidFill>
                    <a:latin typeface="Arial"/>
                  </a:rPr>
                  <a:t>PA2206</a:t>
                </a:r>
                <a:r>
                  <a:rPr b="0" lang="en-IE" sz="1000" spc="-1" strike="noStrike" baseline="30000">
                    <a:solidFill>
                      <a:srgbClr val="000000"/>
                    </a:solidFill>
                    <a:latin typeface="Arial"/>
                  </a:rPr>
                  <a:t>-</a:t>
                </a:r>
                <a:r>
                  <a:rPr b="0" lang="en-IE" sz="1000" spc="-1" strike="noStrike">
                    <a:solidFill>
                      <a:srgbClr val="000000"/>
                    </a:solidFill>
                    <a:latin typeface="Arial"/>
                  </a:rPr>
                  <a:t> + menadio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12"/>
              <p:cNvSpPr/>
              <p:nvPr/>
            </p:nvSpPr>
            <p:spPr>
              <a:xfrm>
                <a:off x="5731200" y="5389200"/>
                <a:ext cx="65340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IE" sz="1000" spc="-1" strike="noStrike">
                    <a:solidFill>
                      <a:srgbClr val="000000"/>
                    </a:solidFill>
                    <a:latin typeface="Arial"/>
                  </a:rPr>
                  <a:t>PA2206</a:t>
                </a:r>
                <a:r>
                  <a:rPr b="0" lang="en-IE" sz="1000" spc="-1" strike="noStrike" baseline="30000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55" name="Straight Arrow Connector 28"/>
            <p:cNvCxnSpPr/>
            <p:nvPr/>
          </p:nvCxnSpPr>
          <p:spPr>
            <a:xfrm>
              <a:off x="2286000" y="4869000"/>
              <a:ext cx="143280" cy="5436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6" name="TextBox 30"/>
            <p:cNvSpPr/>
            <p:nvPr/>
          </p:nvSpPr>
          <p:spPr>
            <a:xfrm>
              <a:off x="1890720" y="4554360"/>
              <a:ext cx="80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Menadio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32"/>
            <p:cNvSpPr/>
            <p:nvPr/>
          </p:nvSpPr>
          <p:spPr>
            <a:xfrm rot="16200000">
              <a:off x="226800" y="5059080"/>
              <a:ext cx="112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Log (OD600n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34"/>
            <p:cNvSpPr/>
            <p:nvPr/>
          </p:nvSpPr>
          <p:spPr>
            <a:xfrm>
              <a:off x="2269800" y="6611760"/>
              <a:ext cx="248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Time post addition of menadione (hr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Box 37"/>
          <p:cNvSpPr/>
          <p:nvPr/>
        </p:nvSpPr>
        <p:spPr>
          <a:xfrm>
            <a:off x="259560" y="295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38"/>
          <p:cNvSpPr/>
          <p:nvPr/>
        </p:nvSpPr>
        <p:spPr>
          <a:xfrm>
            <a:off x="364320" y="3514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9"/>
          <p:cNvSpPr/>
          <p:nvPr/>
        </p:nvSpPr>
        <p:spPr>
          <a:xfrm>
            <a:off x="5738400" y="1184400"/>
            <a:ext cx="622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mPAO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0"/>
          <p:cNvSpPr/>
          <p:nvPr/>
        </p:nvSpPr>
        <p:spPr>
          <a:xfrm>
            <a:off x="5762520" y="1400040"/>
            <a:ext cx="1038600" cy="26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mPAO1 + H</a:t>
            </a:r>
            <a:r>
              <a:rPr b="0" lang="en-IE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IE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1"/>
          <p:cNvSpPr/>
          <p:nvPr/>
        </p:nvSpPr>
        <p:spPr>
          <a:xfrm>
            <a:off x="5749560" y="1874880"/>
            <a:ext cx="1069200" cy="26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PA2206</a:t>
            </a:r>
            <a:r>
              <a:rPr b="0" lang="en-IE" sz="10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 + H</a:t>
            </a:r>
            <a:r>
              <a:rPr b="0" lang="en-IE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IE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2"/>
          <p:cNvSpPr/>
          <p:nvPr/>
        </p:nvSpPr>
        <p:spPr>
          <a:xfrm>
            <a:off x="5739840" y="1630440"/>
            <a:ext cx="6534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PA2206</a:t>
            </a:r>
            <a:r>
              <a:rPr b="0" lang="en-IE" sz="10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5"/>
          <p:cNvSpPr/>
          <p:nvPr/>
        </p:nvSpPr>
        <p:spPr>
          <a:xfrm>
            <a:off x="2555280" y="168588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6"/>
          <p:cNvSpPr/>
          <p:nvPr/>
        </p:nvSpPr>
        <p:spPr>
          <a:xfrm>
            <a:off x="3117600" y="153360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3688920" y="151452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4250880" y="149544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4822560" y="140004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3927600" y="5343480"/>
            <a:ext cx="32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4755960" y="537228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2T08:15:56Z</dcterms:created>
  <dc:creator>lab 441</dc:creator>
  <dc:description/>
  <dc:language>en-US</dc:language>
  <cp:lastModifiedBy>lab 441</cp:lastModifiedBy>
  <dcterms:modified xsi:type="dcterms:W3CDTF">2012-10-10T14:20:17Z</dcterms:modified>
  <cp:revision>10</cp:revision>
  <dc:subject/>
  <dc:title>Slide 1</dc:title>
</cp:coreProperties>
</file>